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docx" ContentType="application/vnd.openxmlformats-officedocument.wordprocessingml.document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1" r:id="rId6"/>
    <p:sldId id="262" r:id="rId7"/>
    <p:sldId id="263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43" autoAdjust="0"/>
    <p:restoredTop sz="93049" autoAdjust="0"/>
  </p:normalViewPr>
  <p:slideViewPr>
    <p:cSldViewPr snapToGrid="0" snapToObjects="1">
      <p:cViewPr>
        <p:scale>
          <a:sx n="150" d="100"/>
          <a:sy n="150" d="100"/>
        </p:scale>
        <p:origin x="-1672" y="21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png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png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png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png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png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606C5-6E32-304B-AAF0-F26385D7D8CF}" type="datetimeFigureOut">
              <a:t>2014/10/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71644-FCB4-2F45-82C6-67363EBABF2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430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606C5-6E32-304B-AAF0-F26385D7D8CF}" type="datetimeFigureOut">
              <a:t>2014/10/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71644-FCB4-2F45-82C6-67363EBABF2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734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606C5-6E32-304B-AAF0-F26385D7D8CF}" type="datetimeFigureOut">
              <a:t>2014/10/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71644-FCB4-2F45-82C6-67363EBABF2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38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606C5-6E32-304B-AAF0-F26385D7D8CF}" type="datetimeFigureOut">
              <a:t>2014/10/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71644-FCB4-2F45-82C6-67363EBABF2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907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606C5-6E32-304B-AAF0-F26385D7D8CF}" type="datetimeFigureOut">
              <a:t>2014/10/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71644-FCB4-2F45-82C6-67363EBABF2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374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606C5-6E32-304B-AAF0-F26385D7D8CF}" type="datetimeFigureOut">
              <a:t>2014/10/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71644-FCB4-2F45-82C6-67363EBABF2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710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606C5-6E32-304B-AAF0-F26385D7D8CF}" type="datetimeFigureOut">
              <a:t>2014/10/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71644-FCB4-2F45-82C6-67363EBABF2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433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606C5-6E32-304B-AAF0-F26385D7D8CF}" type="datetimeFigureOut">
              <a:t>2014/10/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71644-FCB4-2F45-82C6-67363EBABF2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159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606C5-6E32-304B-AAF0-F26385D7D8CF}" type="datetimeFigureOut">
              <a:t>2014/10/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71644-FCB4-2F45-82C6-67363EBABF2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168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606C5-6E32-304B-AAF0-F26385D7D8CF}" type="datetimeFigureOut">
              <a:t>2014/10/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71644-FCB4-2F45-82C6-67363EBABF2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370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606C5-6E32-304B-AAF0-F26385D7D8CF}" type="datetimeFigureOut">
              <a:t>2014/10/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71644-FCB4-2F45-82C6-67363EBABF2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625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D606C5-6E32-304B-AAF0-F26385D7D8CF}" type="datetimeFigureOut">
              <a:t>2014/10/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A71644-FCB4-2F45-82C6-67363EBABF2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700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oleObject" Target="../embeddings/oleObject1.bin"/><Relationship Id="rId5" Type="http://schemas.openxmlformats.org/officeDocument/2006/relationships/package" Target="../embeddings/Microsoft_Word_Document1.docx"/><Relationship Id="rId6" Type="http://schemas.openxmlformats.org/officeDocument/2006/relationships/image" Target="../media/image1.png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oleObject" Target="../embeddings/oleObject2.bin"/><Relationship Id="rId5" Type="http://schemas.openxmlformats.org/officeDocument/2006/relationships/package" Target="../embeddings/Microsoft_Word_Document2.docx"/><Relationship Id="rId6" Type="http://schemas.openxmlformats.org/officeDocument/2006/relationships/image" Target="../media/image3.png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oleObject" Target="../embeddings/oleObject3.bin"/><Relationship Id="rId5" Type="http://schemas.openxmlformats.org/officeDocument/2006/relationships/package" Target="../embeddings/Microsoft_Word_Document3.docx"/><Relationship Id="rId6" Type="http://schemas.openxmlformats.org/officeDocument/2006/relationships/image" Target="../media/image5.png"/><Relationship Id="rId1" Type="http://schemas.openxmlformats.org/officeDocument/2006/relationships/vmlDrawing" Target="../drawings/vmlDrawing3.vml"/><Relationship Id="rId2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oleObject" Target="../embeddings/oleObject4.bin"/><Relationship Id="rId5" Type="http://schemas.openxmlformats.org/officeDocument/2006/relationships/package" Target="../embeddings/Microsoft_Word_Document4.docx"/><Relationship Id="rId6" Type="http://schemas.openxmlformats.org/officeDocument/2006/relationships/image" Target="../media/image7.png"/><Relationship Id="rId1" Type="http://schemas.openxmlformats.org/officeDocument/2006/relationships/vmlDrawing" Target="../drawings/vmlDrawing4.vml"/><Relationship Id="rId2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oleObject" Target="../embeddings/oleObject5.bin"/><Relationship Id="rId5" Type="http://schemas.openxmlformats.org/officeDocument/2006/relationships/package" Target="../embeddings/Microsoft_Word_Document5.docx"/><Relationship Id="rId6" Type="http://schemas.openxmlformats.org/officeDocument/2006/relationships/image" Target="../media/image9.png"/><Relationship Id="rId1" Type="http://schemas.openxmlformats.org/officeDocument/2006/relationships/vmlDrawing" Target="../drawings/vmlDrawing5.vml"/><Relationship Id="rId2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4" Type="http://schemas.openxmlformats.org/officeDocument/2006/relationships/oleObject" Target="../embeddings/oleObject6.bin"/><Relationship Id="rId5" Type="http://schemas.openxmlformats.org/officeDocument/2006/relationships/package" Target="../embeddings/Microsoft_Word_Document6.docx"/><Relationship Id="rId6" Type="http://schemas.openxmlformats.org/officeDocument/2006/relationships/image" Target="../media/image11.png"/><Relationship Id="rId1" Type="http://schemas.openxmlformats.org/officeDocument/2006/relationships/vmlDrawing" Target="../drawings/vmlDrawing6.vml"/><Relationship Id="rId2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4" Type="http://schemas.openxmlformats.org/officeDocument/2006/relationships/oleObject" Target="../embeddings/oleObject7.bin"/><Relationship Id="rId5" Type="http://schemas.openxmlformats.org/officeDocument/2006/relationships/package" Target="../embeddings/Microsoft_Word_Document7.docx"/><Relationship Id="rId6" Type="http://schemas.openxmlformats.org/officeDocument/2006/relationships/image" Target="../media/image13.png"/><Relationship Id="rId1" Type="http://schemas.openxmlformats.org/officeDocument/2006/relationships/vmlDrawing" Target="../drawings/vmlDrawing7.vml"/><Relationship Id="rId2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表格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1253631"/>
              </p:ext>
            </p:extLst>
          </p:nvPr>
        </p:nvGraphicFramePr>
        <p:xfrm>
          <a:off x="1615619" y="3999761"/>
          <a:ext cx="4547098" cy="278533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65752"/>
                <a:gridCol w="454478"/>
                <a:gridCol w="454478"/>
                <a:gridCol w="454478"/>
                <a:gridCol w="454478"/>
                <a:gridCol w="454478"/>
                <a:gridCol w="454478"/>
                <a:gridCol w="454478"/>
              </a:tblGrid>
              <a:tr h="185689"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4</a:t>
                      </a:r>
                      <a:endParaRPr lang="en-US" altLang="zh-TW" sz="1100" b="0" i="0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32</a:t>
                      </a:r>
                      <a:endParaRPr lang="en-US" altLang="zh-TW" sz="1100" b="0" i="0" u="none" strike="noStrike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01</a:t>
                      </a:r>
                      <a:endParaRPr lang="en-US" altLang="zh-TW" sz="1100" b="0" i="0" u="none" strike="noStrike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35</a:t>
                      </a:r>
                      <a:endParaRPr lang="en-US" altLang="zh-TW" sz="1100" b="0" i="0" u="none" strike="noStrike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32</a:t>
                      </a:r>
                      <a:endParaRPr lang="en-US" altLang="zh-TW" sz="1100" b="0" i="0" u="none" strike="noStrike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15</a:t>
                      </a:r>
                      <a:endParaRPr lang="en-US" altLang="zh-TW" sz="1100" b="0" i="0" u="none" strike="noStrike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72</a:t>
                      </a:r>
                      <a:endParaRPr lang="en-US" altLang="zh-TW" sz="1100" b="0" i="0" u="none" strike="noStrike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/>
                </a:tc>
              </a:tr>
              <a:tr h="1856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Utriculari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gibba</a:t>
                      </a:r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0" u="none" strike="noStrike" baseline="30000" dirty="0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R</a:t>
                      </a:r>
                      <a:endParaRPr lang="en-US" sz="1100" b="0" i="0" u="none" strike="noStrike" baseline="30000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6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Mimul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guttatu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</a:tr>
              <a:tr h="1856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Solanum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lycopersicum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6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Viti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vinifer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</a:tr>
              <a:tr h="1856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Arabidopsis AXR1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6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Caric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papaya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</a:tr>
              <a:tr h="1856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Theobrom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cacao 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6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Cucumi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sativ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</a:tr>
              <a:tr h="18568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Medicago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truncatul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6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Phaseol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vulgari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</a:tr>
              <a:tr h="1856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Glycine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max 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6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Fragari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vesc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</a:tr>
              <a:tr h="18568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Prun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persic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689"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75*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91**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45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91**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661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58*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789</a:t>
                      </a:r>
                    </a:p>
                  </a:txBody>
                  <a:tcPr marL="0" marR="0" marT="0" marB="0" anchor="ctr"/>
                </a:tc>
              </a:tr>
            </a:tbl>
          </a:graphicData>
        </a:graphic>
      </p:graphicFrame>
      <p:pic>
        <p:nvPicPr>
          <p:cNvPr id="14" name="圖片 13" descr="AXR1-tree-label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6530" y="4227335"/>
            <a:ext cx="933381" cy="2376000"/>
          </a:xfrm>
          <a:prstGeom prst="rect">
            <a:avLst/>
          </a:prstGeom>
        </p:spPr>
      </p:pic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5330247"/>
              </p:ext>
            </p:extLst>
          </p:nvPr>
        </p:nvGraphicFramePr>
        <p:xfrm>
          <a:off x="412751" y="1155291"/>
          <a:ext cx="6032500" cy="25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" name="Document" r:id="rId5" imgW="6032500" imgH="2540000" progId="Word.Document.12">
                  <p:embed/>
                </p:oleObj>
              </mc:Choice>
              <mc:Fallback>
                <p:oleObj name="Document" r:id="rId5" imgW="6032500" imgH="25400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2751" y="1155291"/>
                        <a:ext cx="6032500" cy="25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9518847"/>
              </p:ext>
            </p:extLst>
          </p:nvPr>
        </p:nvGraphicFramePr>
        <p:xfrm>
          <a:off x="133554" y="7072715"/>
          <a:ext cx="6573855" cy="1143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73494"/>
                <a:gridCol w="1123328"/>
                <a:gridCol w="911687"/>
                <a:gridCol w="1595452"/>
                <a:gridCol w="993087"/>
                <a:gridCol w="976807"/>
              </a:tblGrid>
              <a:tr h="228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i="1" u="none" strike="noStrike" dirty="0">
                          <a:effectLst/>
                        </a:rPr>
                        <a:t>Arabidopsis AXR1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AT1G05180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i="1" u="none" strike="noStrike" dirty="0" err="1">
                          <a:effectLst/>
                        </a:rPr>
                        <a:t>Carica</a:t>
                      </a:r>
                      <a:r>
                        <a:rPr lang="en-US" sz="800" i="1" u="none" strike="noStrike" dirty="0">
                          <a:effectLst/>
                        </a:rPr>
                        <a:t> papay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</a:rPr>
                        <a:t>EVM prediction supercontig_87.7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i="1" u="none" strike="noStrike" dirty="0" err="1">
                          <a:effectLst/>
                        </a:rPr>
                        <a:t>Medicago</a:t>
                      </a:r>
                      <a:r>
                        <a:rPr lang="en-US" sz="800" i="1" u="none" strike="noStrike" dirty="0">
                          <a:effectLst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</a:rPr>
                        <a:t>truncatul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800" u="none" strike="noStrike" dirty="0">
                          <a:effectLst/>
                        </a:rPr>
                        <a:t>Medtr4g048220</a:t>
                      </a:r>
                      <a:endParaRPr lang="da-DK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i="1" u="none" strike="noStrike" dirty="0" err="1">
                          <a:effectLst/>
                        </a:rPr>
                        <a:t>Utricularia</a:t>
                      </a:r>
                      <a:r>
                        <a:rPr lang="en-US" sz="800" i="1" u="none" strike="noStrike" dirty="0">
                          <a:effectLst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</a:rPr>
                        <a:t>gibb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Scf00011.g1809.t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i="1" u="none" strike="noStrike" dirty="0" err="1">
                          <a:effectLst/>
                        </a:rPr>
                        <a:t>Cucumis</a:t>
                      </a:r>
                      <a:r>
                        <a:rPr lang="en-US" sz="800" i="1" u="none" strike="noStrike" dirty="0">
                          <a:effectLst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</a:rPr>
                        <a:t>sativus</a:t>
                      </a:r>
                      <a:r>
                        <a:rPr lang="en-US" sz="800" i="1" u="none" strike="noStrike" dirty="0">
                          <a:effectLst/>
                        </a:rPr>
                        <a:t> 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u-HU" sz="800" u="none" strike="noStrike" dirty="0">
                          <a:effectLst/>
                        </a:rPr>
                        <a:t>Csa2M418860.1</a:t>
                      </a:r>
                      <a:endParaRPr lang="hu-HU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i="1" u="none" strike="noStrike" dirty="0" err="1">
                          <a:effectLst/>
                        </a:rPr>
                        <a:t>Phaseolus</a:t>
                      </a:r>
                      <a:r>
                        <a:rPr lang="en-US" sz="800" i="1" u="none" strike="noStrike" dirty="0">
                          <a:effectLst/>
                        </a:rPr>
                        <a:t> vulgaris 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PAC:2715276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i="1" u="none" strike="noStrike" dirty="0" err="1">
                          <a:effectLst/>
                        </a:rPr>
                        <a:t>Mimulus</a:t>
                      </a:r>
                      <a:r>
                        <a:rPr lang="en-US" sz="800" i="1" u="none" strike="noStrike" dirty="0">
                          <a:effectLst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</a:rPr>
                        <a:t>guttat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u-HU" sz="800" u="none" strike="noStrike" dirty="0">
                          <a:effectLst/>
                        </a:rPr>
                        <a:t>mgf011181m</a:t>
                      </a:r>
                      <a:endParaRPr lang="hu-HU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i="1" u="none" strike="noStrike" dirty="0" err="1">
                          <a:effectLst/>
                        </a:rPr>
                        <a:t>Fragaria</a:t>
                      </a:r>
                      <a:r>
                        <a:rPr lang="en-US" sz="800" i="1" u="none" strike="noStrike" dirty="0">
                          <a:effectLst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</a:rPr>
                        <a:t>vesca</a:t>
                      </a:r>
                      <a:r>
                        <a:rPr lang="en-US" sz="800" i="1" u="none" strike="noStrike" dirty="0">
                          <a:effectLst/>
                        </a:rPr>
                        <a:t> 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800" u="none" strike="noStrike" dirty="0">
                          <a:effectLst/>
                        </a:rPr>
                        <a:t>mrna23778.1-v1.0-hybrid</a:t>
                      </a:r>
                      <a:endParaRPr lang="cs-CZ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i="1" u="none" strike="noStrike" dirty="0" err="1">
                          <a:effectLst/>
                        </a:rPr>
                        <a:t>Prunus</a:t>
                      </a:r>
                      <a:r>
                        <a:rPr lang="en-US" sz="800" i="1" u="none" strike="noStrike" dirty="0">
                          <a:effectLst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</a:rPr>
                        <a:t>persica</a:t>
                      </a:r>
                      <a:r>
                        <a:rPr lang="en-US" sz="800" i="1" u="none" strike="noStrike" dirty="0">
                          <a:effectLst/>
                        </a:rPr>
                        <a:t> 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PAC:1764554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i="1" u="none" strike="noStrike" dirty="0" err="1">
                          <a:effectLst/>
                        </a:rPr>
                        <a:t>Solanum</a:t>
                      </a:r>
                      <a:r>
                        <a:rPr lang="en-US" sz="800" i="1" u="none" strike="noStrike" dirty="0">
                          <a:effectLst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</a:rPr>
                        <a:t>lycopersicum</a:t>
                      </a:r>
                      <a:r>
                        <a:rPr lang="en-US" sz="800" i="1" u="none" strike="noStrike" dirty="0">
                          <a:effectLst/>
                        </a:rPr>
                        <a:t> 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 dirty="0">
                          <a:effectLst/>
                        </a:rPr>
                        <a:t>Solyc11g072460.1</a:t>
                      </a:r>
                      <a:endParaRPr lang="sv-SE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i="1" u="none" strike="noStrike" dirty="0">
                          <a:effectLst/>
                        </a:rPr>
                        <a:t>Glycine max 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PAC:2629401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i="1" u="none" strike="noStrike" dirty="0" err="1">
                          <a:effectLst/>
                        </a:rPr>
                        <a:t>Theobroma</a:t>
                      </a:r>
                      <a:r>
                        <a:rPr lang="en-US" sz="800" i="1" u="none" strike="noStrike" dirty="0">
                          <a:effectLst/>
                        </a:rPr>
                        <a:t> cacao 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</a:rPr>
                        <a:t>Tc02_g03072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i="1" u="none" strike="noStrike" dirty="0" err="1">
                          <a:effectLst/>
                        </a:rPr>
                        <a:t>Vitis</a:t>
                      </a:r>
                      <a:r>
                        <a:rPr lang="en-US" sz="800" i="1" u="none" strike="noStrike" dirty="0">
                          <a:effectLst/>
                        </a:rPr>
                        <a:t> </a:t>
                      </a:r>
                      <a:r>
                        <a:rPr lang="en-US" sz="800" i="1" u="none" strike="noStrike" dirty="0" err="1">
                          <a:effectLst/>
                        </a:rPr>
                        <a:t>vinifer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GSVIVT0103042300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12751" y="685069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412751" y="3610879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888056" y="3614633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133554" y="270933"/>
            <a:ext cx="1839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. Fig. </a:t>
            </a:r>
            <a:r>
              <a:rPr lang="en-US" dirty="0"/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09550668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8463112"/>
              </p:ext>
            </p:extLst>
          </p:nvPr>
        </p:nvGraphicFramePr>
        <p:xfrm>
          <a:off x="1700434" y="3553191"/>
          <a:ext cx="4817688" cy="35143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38054"/>
                <a:gridCol w="425662"/>
                <a:gridCol w="425662"/>
                <a:gridCol w="425662"/>
                <a:gridCol w="425662"/>
                <a:gridCol w="425662"/>
                <a:gridCol w="425662"/>
                <a:gridCol w="425662"/>
              </a:tblGrid>
              <a:tr h="266400"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4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6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5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55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56</a:t>
                      </a:r>
                    </a:p>
                  </a:txBody>
                  <a:tcPr marL="12700" marR="12700" marT="12700" marB="0" anchor="ctr"/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Utricularia gibba</a:t>
                      </a:r>
                    </a:p>
                  </a:txBody>
                  <a:tcPr marL="12700" marR="12700" marT="1270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H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mulus guttatus</a:t>
                      </a:r>
                    </a:p>
                  </a:txBody>
                  <a:tcPr marL="12700" marR="12700" marT="1270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12700" marR="12700" marT="12700" marB="0" anchor="ctr"/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ffe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nephor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</a:p>
                  </a:txBody>
                  <a:tcPr marL="12700" marR="12700" marT="1270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olanum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ycopersicum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</a:p>
                  </a:txBody>
                  <a:tcPr marL="12700" marR="12700" marT="1270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12700" marR="12700" marT="12700" marB="0" anchor="ctr"/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iti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inifer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eobroma cacao </a:t>
                      </a:r>
                    </a:p>
                  </a:txBody>
                  <a:tcPr marL="12700" marR="12700" marT="1270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12700" marR="12700" marT="12700" marB="0" anchor="ctr"/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rica papaya</a:t>
                      </a:r>
                    </a:p>
                  </a:txBody>
                  <a:tcPr marL="12700" marR="12700" marT="1270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317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rabidopsis </a:t>
                      </a:r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haliana UMAMIT4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12700" marR="12700" marT="12700" marB="0" anchor="ctr"/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ragaria vesca </a:t>
                      </a:r>
                    </a:p>
                  </a:txBody>
                  <a:tcPr marL="12700" marR="12700" marT="1270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itrull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anat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ar.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anat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</a:p>
                  </a:txBody>
                  <a:tcPr marL="12700" marR="12700" marT="1270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12700" marR="12700" marT="12700" marB="0" anchor="ctr"/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ucumi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tiv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</a:p>
                  </a:txBody>
                  <a:tcPr marL="12700" marR="12700" marT="1270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12700" marR="12700" marT="1270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66400"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848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869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59*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736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514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753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984*</a:t>
                      </a:r>
                    </a:p>
                  </a:txBody>
                  <a:tcPr marL="12700" marR="12700" marT="12700" marB="0" anchor="ctr"/>
                </a:tc>
              </a:tr>
            </a:tbl>
          </a:graphicData>
        </a:graphic>
      </p:graphicFrame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2451" y="3976546"/>
            <a:ext cx="1033635" cy="2808000"/>
          </a:xfrm>
          <a:prstGeom prst="rect">
            <a:avLst/>
          </a:prstGeom>
        </p:spPr>
      </p:pic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8326821"/>
              </p:ext>
            </p:extLst>
          </p:nvPr>
        </p:nvGraphicFramePr>
        <p:xfrm>
          <a:off x="319617" y="1127339"/>
          <a:ext cx="6198505" cy="23711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4" name="Document" r:id="rId5" imgW="6108700" imgH="2336800" progId="Word.Document.12">
                  <p:embed/>
                </p:oleObj>
              </mc:Choice>
              <mc:Fallback>
                <p:oleObj name="Document" r:id="rId5" imgW="6108700" imgH="23368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19617" y="1127339"/>
                        <a:ext cx="6198505" cy="23711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5370772"/>
              </p:ext>
            </p:extLst>
          </p:nvPr>
        </p:nvGraphicFramePr>
        <p:xfrm>
          <a:off x="202636" y="7530441"/>
          <a:ext cx="6538383" cy="1124820"/>
        </p:xfrm>
        <a:graphic>
          <a:graphicData uri="http://schemas.openxmlformats.org/drawingml/2006/table">
            <a:tbl>
              <a:tblPr/>
              <a:tblGrid>
                <a:gridCol w="1050730"/>
                <a:gridCol w="1203231"/>
                <a:gridCol w="1014736"/>
                <a:gridCol w="1057496"/>
                <a:gridCol w="1336923"/>
                <a:gridCol w="875267"/>
              </a:tblGrid>
              <a:tr h="28120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triculari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ibb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1962" marR="11962" marT="11962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cf00084.g7619.t1</a:t>
                      </a:r>
                    </a:p>
                  </a:txBody>
                  <a:tcPr marL="11962" marR="11962" marT="11962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iti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inifer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1962" marR="11962" marT="11962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VIVT01032511001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1962" marR="11962" marT="11962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ragari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esc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1962" marR="11962" marT="11962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rna32153.1-v1.0-hybrid</a:t>
                      </a:r>
                    </a:p>
                  </a:txBody>
                  <a:tcPr marL="11962" marR="11962" marT="11962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120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mul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uttat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1962" marR="11962" marT="11962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u-H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gf014968m</a:t>
                      </a:r>
                    </a:p>
                  </a:txBody>
                  <a:tcPr marL="11962" marR="11962" marT="11962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heobrom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cacao </a:t>
                      </a:r>
                    </a:p>
                  </a:txBody>
                  <a:tcPr marL="11962" marR="11962" marT="11962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c04_g000510</a:t>
                      </a:r>
                    </a:p>
                  </a:txBody>
                  <a:tcPr marL="11962" marR="11962" marT="11962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itrull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nat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ar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nat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1962" marR="11962" marT="11962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a010387</a:t>
                      </a:r>
                    </a:p>
                  </a:txBody>
                  <a:tcPr marL="11962" marR="11962" marT="11962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120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ffe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nephor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1962" marR="11962" marT="11962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COCT00039442001</a:t>
                      </a:r>
                    </a:p>
                  </a:txBody>
                  <a:tcPr marL="11962" marR="11962" marT="11962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ric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papaya</a:t>
                      </a:r>
                    </a:p>
                  </a:txBody>
                  <a:tcPr marL="11962" marR="11962" marT="11962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VM prediction supercontig_286.2</a:t>
                      </a:r>
                    </a:p>
                  </a:txBody>
                  <a:tcPr marL="11962" marR="11962" marT="11962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ucumi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tiv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1962" marR="11962" marT="11962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u-H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sa5M630930.1</a:t>
                      </a:r>
                    </a:p>
                  </a:txBody>
                  <a:tcPr marL="11962" marR="11962" marT="11962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120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anum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ycopersicum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1962" marR="11962" marT="11962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yc02g087060.2</a:t>
                      </a:r>
                    </a:p>
                  </a:txBody>
                  <a:tcPr marL="11962" marR="11962" marT="11962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rabidopsis thaliana</a:t>
                      </a:r>
                    </a:p>
                  </a:txBody>
                  <a:tcPr marL="11962" marR="11962" marT="11962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3G28050.1</a:t>
                      </a:r>
                    </a:p>
                  </a:txBody>
                  <a:tcPr marL="11962" marR="11962" marT="11962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1962" marR="11962" marT="11962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1962" marR="11962" marT="1196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412751" y="685069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12751" y="3610879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158984" y="3614633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33554" y="270933"/>
            <a:ext cx="1839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. Fig.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8881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6411665"/>
              </p:ext>
            </p:extLst>
          </p:nvPr>
        </p:nvGraphicFramePr>
        <p:xfrm>
          <a:off x="1994754" y="3614127"/>
          <a:ext cx="4225070" cy="296126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31920"/>
                <a:gridCol w="498630"/>
                <a:gridCol w="498630"/>
                <a:gridCol w="498630"/>
                <a:gridCol w="498630"/>
                <a:gridCol w="498630"/>
              </a:tblGrid>
              <a:tr h="185079"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78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4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15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3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82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Utriculari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gibb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Mimul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guttatu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Solanum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lycopersicum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Citrus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clementin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Citrus </a:t>
                      </a:r>
                      <a:r>
                        <a:rPr lang="en-US" sz="1100" b="0" i="1" u="none" strike="noStrike" dirty="0" err="1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sinensis</a:t>
                      </a:r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0" u="none" strike="noStrike" baseline="30000" dirty="0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R </a:t>
                      </a:r>
                      <a:endParaRPr lang="en-US" sz="1100" b="0" i="0" u="none" strike="noStrike" baseline="30000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Caric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papaya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Arabidopsis </a:t>
                      </a:r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thaliana IG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Linum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usitatissimum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Popul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trichocarp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Phaseol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vulgaris </a:t>
                      </a:r>
                      <a:r>
                        <a:rPr lang="en-US" sz="1100" b="0" i="0" u="none" strike="noStrike" baseline="30000" dirty="0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R</a:t>
                      </a:r>
                      <a:endParaRPr lang="en-US" sz="1100" b="0" i="0" u="none" strike="noStrike" baseline="30000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Prun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persic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Cucumi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sativ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Citrull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lanat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var.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lanat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Viti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vinifer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562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31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59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33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711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88472" y="3920645"/>
            <a:ext cx="1489569" cy="241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224607"/>
              </p:ext>
            </p:extLst>
          </p:nvPr>
        </p:nvGraphicFramePr>
        <p:xfrm>
          <a:off x="412751" y="855407"/>
          <a:ext cx="6032500" cy="2336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8" name="Document" r:id="rId5" imgW="6032500" imgH="2336800" progId="Word.Document.12">
                  <p:embed/>
                </p:oleObj>
              </mc:Choice>
              <mc:Fallback>
                <p:oleObj name="Document" r:id="rId5" imgW="6032500" imgH="23368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2751" y="855407"/>
                        <a:ext cx="6032500" cy="2336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678281"/>
              </p:ext>
            </p:extLst>
          </p:nvPr>
        </p:nvGraphicFramePr>
        <p:xfrm>
          <a:off x="311151" y="7022258"/>
          <a:ext cx="6415145" cy="1282700"/>
        </p:xfrm>
        <a:graphic>
          <a:graphicData uri="http://schemas.openxmlformats.org/drawingml/2006/table">
            <a:tbl>
              <a:tblPr/>
              <a:tblGrid>
                <a:gridCol w="1122571"/>
                <a:gridCol w="1236216"/>
                <a:gridCol w="1081688"/>
                <a:gridCol w="1046152"/>
                <a:gridCol w="874889"/>
                <a:gridCol w="1053629"/>
              </a:tblGrid>
              <a:tr h="2565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triculari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ibb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cf00260.g14017.t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ric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papay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VM prediction supercontig_136.36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un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rsic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C:17652969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5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mul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uttat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u-H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gf010658m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rabidopsis thalian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2G04400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ucumi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tiv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u-H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sa7M031620.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5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anum lycopersicum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yc03g111850.2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inum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sitatissimum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us10006354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itrullus lanatus 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ar.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lanatus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a015699;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5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itrus clementin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ementine0.9_012164m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opul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richocarp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C:27032465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iti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inifer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VIVG0103011600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5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itrus sinensis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range1.1g015424m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haseolus vulgaris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C:27153956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412751" y="417725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12751" y="3410371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305856" y="3414125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33554" y="86267"/>
            <a:ext cx="1839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. Fig. </a:t>
            </a:r>
            <a:r>
              <a:rPr lang="en-US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300678818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0223546"/>
              </p:ext>
            </p:extLst>
          </p:nvPr>
        </p:nvGraphicFramePr>
        <p:xfrm>
          <a:off x="1068341" y="3576171"/>
          <a:ext cx="5482575" cy="256311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21407"/>
                <a:gridCol w="378288"/>
                <a:gridCol w="378288"/>
                <a:gridCol w="378288"/>
                <a:gridCol w="378288"/>
                <a:gridCol w="378288"/>
                <a:gridCol w="378288"/>
                <a:gridCol w="378288"/>
                <a:gridCol w="378288"/>
                <a:gridCol w="378288"/>
                <a:gridCol w="378288"/>
                <a:gridCol w="378288"/>
              </a:tblGrid>
              <a:tr h="213593">
                <a:tc>
                  <a:txBody>
                    <a:bodyPr/>
                    <a:lstStyle/>
                    <a:p>
                      <a:pPr algn="l" fontAlgn="ctr"/>
                      <a:endParaRPr lang="zh-TW" alt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13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5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7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87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96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19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63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8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73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1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15</a:t>
                      </a:r>
                    </a:p>
                  </a:txBody>
                  <a:tcPr marL="0" marR="0" marT="0" marB="0" anchor="ctr"/>
                </a:tc>
              </a:tr>
              <a:tr h="21359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Utriculari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gibb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359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Mimulus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guttatu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/>
                </a:tc>
              </a:tr>
              <a:tr h="21359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Solanum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lycopersicum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359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Vitis vinifera</a:t>
                      </a: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/>
                </a:tc>
              </a:tr>
              <a:tr h="21359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Glycine </a:t>
                      </a:r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max</a:t>
                      </a:r>
                      <a:r>
                        <a:rPr lang="en-US" sz="1100" b="0" i="0" u="none" strike="noStrike" baseline="30000" dirty="0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R </a:t>
                      </a:r>
                      <a:endParaRPr lang="en-US" sz="1100" b="0" i="0" u="none" strike="noStrike" baseline="30000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359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Prunus persica </a:t>
                      </a: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/>
                </a:tc>
              </a:tr>
              <a:tr h="21359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Fragaria vesca </a:t>
                      </a: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359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Citrus sinensis </a:t>
                      </a: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/>
                </a:tc>
              </a:tr>
              <a:tr h="21359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Theobroma</a:t>
                      </a:r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cacao </a:t>
                      </a:r>
                      <a:r>
                        <a:rPr lang="en-US" sz="1100" b="0" i="0" u="none" strike="noStrike" baseline="30000" dirty="0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R</a:t>
                      </a:r>
                      <a:r>
                        <a:rPr lang="en-US" sz="1100" b="0" i="1" u="none" strike="noStrike" dirty="0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359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Arabidopsis TAR2</a:t>
                      </a: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D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/>
                </a:tc>
              </a:tr>
              <a:tr h="213593">
                <a:tc>
                  <a:txBody>
                    <a:bodyPr/>
                    <a:lstStyle/>
                    <a:p>
                      <a:pPr algn="l" fontAlgn="ctr"/>
                      <a:endParaRPr lang="zh-TW" alt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894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57*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28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42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89*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49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534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657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94**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31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605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pic>
        <p:nvPicPr>
          <p:cNvPr id="14" name="圖片 13" descr="TAR2-tree-label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9607" y="3868149"/>
            <a:ext cx="630151" cy="2052000"/>
          </a:xfrm>
          <a:prstGeom prst="rect">
            <a:avLst/>
          </a:prstGeom>
        </p:spPr>
      </p:pic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0797331"/>
              </p:ext>
            </p:extLst>
          </p:nvPr>
        </p:nvGraphicFramePr>
        <p:xfrm>
          <a:off x="453608" y="1020097"/>
          <a:ext cx="6032500" cy="2476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2" name="Document" r:id="rId5" imgW="6032500" imgH="2476500" progId="Word.Document.12">
                  <p:embed/>
                </p:oleObj>
              </mc:Choice>
              <mc:Fallback>
                <p:oleObj name="Document" r:id="rId5" imgW="6032500" imgH="24765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53608" y="1020097"/>
                        <a:ext cx="6032500" cy="2476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12751" y="584815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12751" y="3410371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002320" y="3414125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8815659"/>
              </p:ext>
            </p:extLst>
          </p:nvPr>
        </p:nvGraphicFramePr>
        <p:xfrm>
          <a:off x="412751" y="6775216"/>
          <a:ext cx="6032502" cy="828040"/>
        </p:xfrm>
        <a:graphic>
          <a:graphicData uri="http://schemas.openxmlformats.org/drawingml/2006/table">
            <a:tbl>
              <a:tblPr/>
              <a:tblGrid>
                <a:gridCol w="1005417"/>
                <a:gridCol w="1065388"/>
                <a:gridCol w="945446"/>
                <a:gridCol w="1005417"/>
                <a:gridCol w="1005417"/>
                <a:gridCol w="1005417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triculari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ibb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cf00083.g7570.t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ycine max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C:26305429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itrus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inensi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range1.1g012785m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mul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uttat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u-H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gf001043m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un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rsic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C:1764886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heobrom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cacao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c03_g002020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anum lycopersicum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yc03g112460.2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ragari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esc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rna31790.1-v1.0-hybrid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rabidopsis TAR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4G24670.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itis vinifer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VIVT0100767900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133554" y="270933"/>
            <a:ext cx="1839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. Fig. 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060792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7090720"/>
              </p:ext>
            </p:extLst>
          </p:nvPr>
        </p:nvGraphicFramePr>
        <p:xfrm>
          <a:off x="2253801" y="3422388"/>
          <a:ext cx="4229234" cy="314634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10434"/>
                <a:gridCol w="543760"/>
                <a:gridCol w="543760"/>
                <a:gridCol w="543760"/>
                <a:gridCol w="543760"/>
                <a:gridCol w="543760"/>
              </a:tblGrid>
              <a:tr h="185079">
                <a:tc>
                  <a:txBody>
                    <a:bodyPr/>
                    <a:lstStyle/>
                    <a:p>
                      <a:pPr algn="l" fontAlgn="ctr"/>
                      <a:endParaRPr lang="zh-TW" alt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10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59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75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89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90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1" u="none" strike="noStrike" dirty="0" err="1">
                          <a:latin typeface="Arial" pitchFamily="34" charset="0"/>
                          <a:cs typeface="Arial" pitchFamily="34" charset="0"/>
                        </a:rPr>
                        <a:t>Utricularia</a:t>
                      </a:r>
                      <a:r>
                        <a:rPr lang="en-US" sz="900" b="1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b="1" i="1" u="none" strike="noStrike" dirty="0" err="1" smtClean="0">
                          <a:latin typeface="Arial" pitchFamily="34" charset="0"/>
                          <a:cs typeface="Arial" pitchFamily="34" charset="0"/>
                        </a:rPr>
                        <a:t>gibba</a:t>
                      </a:r>
                      <a:r>
                        <a:rPr lang="en-US" sz="900" b="1" i="1" u="none" strike="noStrike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b="0" i="0" u="none" strike="noStrike" baseline="30000" dirty="0" smtClean="0">
                          <a:latin typeface="Arial" pitchFamily="34" charset="0"/>
                          <a:cs typeface="Arial" pitchFamily="34" charset="0"/>
                        </a:rPr>
                        <a:t>R</a:t>
                      </a:r>
                      <a:endParaRPr lang="en-US" sz="900" b="0" i="0" u="none" strike="noStrike" baseline="30000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M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N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Mimulus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guttatus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Solanum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lycopersicum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Carica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papaya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Arabidopsis SOL1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Citrus </a:t>
                      </a:r>
                      <a:r>
                        <a:rPr lang="en-US" sz="900" i="1" u="none" strike="noStrike" dirty="0" err="1" smtClean="0">
                          <a:latin typeface="Arial" pitchFamily="34" charset="0"/>
                          <a:cs typeface="Arial" pitchFamily="34" charset="0"/>
                        </a:rPr>
                        <a:t>clementina</a:t>
                      </a:r>
                      <a:r>
                        <a:rPr lang="en-US" sz="900" i="1" u="none" strike="noStrike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i="0" u="none" strike="noStrike" baseline="30000" dirty="0" smtClean="0">
                          <a:latin typeface="Arial" pitchFamily="34" charset="0"/>
                          <a:cs typeface="Arial" pitchFamily="34" charset="0"/>
                        </a:rPr>
                        <a:t>R</a:t>
                      </a:r>
                      <a:endParaRPr lang="en-US" sz="900" b="0" i="0" u="none" strike="noStrike" baseline="30000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Theobroma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cacao 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Citrullus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lanatus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i="0" u="none" strike="noStrike" dirty="0">
                          <a:latin typeface="Arial" pitchFamily="34" charset="0"/>
                          <a:cs typeface="Arial" pitchFamily="34" charset="0"/>
                        </a:rPr>
                        <a:t>var. </a:t>
                      </a:r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lanatus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Cucumis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sativus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Glycine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max 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Prunus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persica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Fragaria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vesca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Populus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i="1" u="none" strike="noStrike" dirty="0" err="1" smtClean="0">
                          <a:latin typeface="Arial" pitchFamily="34" charset="0"/>
                          <a:cs typeface="Arial" pitchFamily="34" charset="0"/>
                        </a:rPr>
                        <a:t>trichocarpa</a:t>
                      </a:r>
                      <a:r>
                        <a:rPr lang="en-US" sz="900" i="1" u="none" strike="noStrike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i="0" u="none" strike="noStrike" baseline="30000" dirty="0" smtClean="0">
                          <a:latin typeface="Arial" pitchFamily="34" charset="0"/>
                          <a:cs typeface="Arial" pitchFamily="34" charset="0"/>
                        </a:rPr>
                        <a:t>R</a:t>
                      </a:r>
                      <a:endParaRPr lang="en-US" sz="900" b="0" i="0" u="none" strike="noStrike" baseline="30000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Manihot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esculenta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/>
                </a:tc>
              </a:tr>
              <a:tr h="18507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Vitis</a:t>
                      </a:r>
                      <a:r>
                        <a:rPr lang="en-US" sz="900" i="1" u="none" strike="noStrike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vinifera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G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5079">
                <a:tc>
                  <a:txBody>
                    <a:bodyPr/>
                    <a:lstStyle/>
                    <a:p>
                      <a:pPr algn="l" fontAlgn="ctr"/>
                      <a:endParaRPr lang="zh-TW" alt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75*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4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85*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33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585</a:t>
                      </a:r>
                    </a:p>
                  </a:txBody>
                  <a:tcPr marL="0" marR="0" marT="0" marB="0" anchor="ctr"/>
                </a:tc>
              </a:tr>
            </a:tbl>
          </a:graphicData>
        </a:graphic>
      </p:graphicFrame>
      <p:pic>
        <p:nvPicPr>
          <p:cNvPr id="24577" name="Picture 1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67402" y="3679959"/>
            <a:ext cx="1556295" cy="264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9659556"/>
              </p:ext>
            </p:extLst>
          </p:nvPr>
        </p:nvGraphicFramePr>
        <p:xfrm>
          <a:off x="412751" y="1066800"/>
          <a:ext cx="6032500" cy="2336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69" name="Document" r:id="rId5" imgW="6032500" imgH="2336800" progId="Word.Document.12">
                  <p:embed/>
                </p:oleObj>
              </mc:Choice>
              <mc:Fallback>
                <p:oleObj name="Document" r:id="rId5" imgW="6032500" imgH="23368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2751" y="1066800"/>
                        <a:ext cx="6032500" cy="2336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93623" y="697468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93623" y="3353692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401439" y="3357446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1676701"/>
              </p:ext>
            </p:extLst>
          </p:nvPr>
        </p:nvGraphicFramePr>
        <p:xfrm>
          <a:off x="200687" y="6815667"/>
          <a:ext cx="6457947" cy="1693335"/>
        </p:xfrm>
        <a:graphic>
          <a:graphicData uri="http://schemas.openxmlformats.org/drawingml/2006/table">
            <a:tbl>
              <a:tblPr/>
              <a:tblGrid>
                <a:gridCol w="1081614"/>
                <a:gridCol w="987777"/>
                <a:gridCol w="1382889"/>
                <a:gridCol w="1157111"/>
                <a:gridCol w="915893"/>
                <a:gridCol w="932663"/>
              </a:tblGrid>
              <a:tr h="3386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triculari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ibb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cf00505.g18737.t1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itrus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ementin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ementine0.9_029363m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un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rsic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C:17650385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86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anum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ycopersicum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yc04g072010.2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heobrom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cacao </a:t>
                      </a: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c00_g009890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ragari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esc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rna27579.1-v1.0-hybrid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86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mulus guttatus</a:t>
                      </a: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u-H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gf008446m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itrull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natu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var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nat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a013785;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opulus trichocarpa</a:t>
                      </a: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C:27031254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86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rica papaya</a:t>
                      </a: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VM prediction supercontig_26.81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ucumis sativus </a:t>
                      </a: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u-H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sa6M054840.1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nihot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sculent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ssava4.1_022040m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86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rabidopsis SOL1</a:t>
                      </a: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1G71696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ycine max </a:t>
                      </a: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C:26346015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iti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inifer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0605" marR="10605" marT="1060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VIVG01001409001</a:t>
                      </a:r>
                    </a:p>
                  </a:txBody>
                  <a:tcPr marL="10605" marR="10605" marT="10605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133554" y="270933"/>
            <a:ext cx="1839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. Fig. 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327692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表格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3171566"/>
              </p:ext>
            </p:extLst>
          </p:nvPr>
        </p:nvGraphicFramePr>
        <p:xfrm>
          <a:off x="2336765" y="3549913"/>
          <a:ext cx="3349295" cy="3196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95103"/>
                <a:gridCol w="777096"/>
                <a:gridCol w="777096"/>
              </a:tblGrid>
              <a:tr h="266400"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u="none" strike="noStrike" dirty="0">
                          <a:latin typeface="Calibri" pitchFamily="34" charset="0"/>
                          <a:cs typeface="Arial" pitchFamily="34" charset="0"/>
                        </a:rPr>
                        <a:t>212</a:t>
                      </a:r>
                      <a:endParaRPr lang="en-US" altLang="zh-TW" sz="1100" b="0" i="0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u="none" strike="noStrike">
                          <a:latin typeface="Calibri" pitchFamily="34" charset="0"/>
                          <a:cs typeface="Arial" pitchFamily="34" charset="0"/>
                        </a:rPr>
                        <a:t>345</a:t>
                      </a:r>
                      <a:endParaRPr lang="en-US" altLang="zh-TW" sz="1100" b="0" i="0" u="none" strike="noStrike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/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Utricularia</a:t>
                      </a:r>
                      <a:r>
                        <a:rPr lang="en-US" sz="1100" b="1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b="1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gibba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latin typeface="Courier New"/>
                          <a:cs typeface="Courier New"/>
                        </a:rPr>
                        <a:t>Q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Mimulus</a:t>
                      </a:r>
                      <a:r>
                        <a:rPr lang="en-US" sz="110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guttatu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Coffea</a:t>
                      </a:r>
                      <a:r>
                        <a:rPr lang="en-US" sz="110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canephora</a:t>
                      </a:r>
                      <a:r>
                        <a:rPr lang="en-US" sz="110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Solanum</a:t>
                      </a:r>
                      <a:r>
                        <a:rPr lang="en-US" sz="110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i="1" u="none" strike="noStrike" dirty="0" err="1" smtClean="0">
                          <a:latin typeface="Calibri" pitchFamily="34" charset="0"/>
                          <a:cs typeface="Arial" pitchFamily="34" charset="0"/>
                        </a:rPr>
                        <a:t>lycopersicum</a:t>
                      </a:r>
                      <a:r>
                        <a:rPr lang="en-US" sz="1100" i="1" u="none" strike="noStrike" dirty="0" smtClean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i="0" u="none" strike="noStrike" baseline="30000" dirty="0" smtClean="0">
                          <a:latin typeface="Calibri" pitchFamily="34" charset="0"/>
                          <a:cs typeface="Arial" pitchFamily="34" charset="0"/>
                        </a:rPr>
                        <a:t>R</a:t>
                      </a:r>
                      <a:r>
                        <a:rPr lang="en-US" sz="1100" i="1" u="none" strike="noStrike" dirty="0" smtClean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Vitis</a:t>
                      </a:r>
                      <a:r>
                        <a:rPr lang="en-US" sz="110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i="1" u="none" strike="noStrike" dirty="0" err="1" smtClean="0">
                          <a:latin typeface="Calibri" pitchFamily="34" charset="0"/>
                          <a:cs typeface="Arial" pitchFamily="34" charset="0"/>
                        </a:rPr>
                        <a:t>vinifera</a:t>
                      </a:r>
                      <a:r>
                        <a:rPr lang="en-US" sz="1100" i="1" u="none" strike="noStrike" dirty="0" smtClean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i="0" u="none" strike="noStrike" baseline="30000" dirty="0" smtClean="0">
                          <a:latin typeface="Calibri" pitchFamily="34" charset="0"/>
                          <a:cs typeface="Arial" pitchFamily="34" charset="0"/>
                        </a:rPr>
                        <a:t>R</a:t>
                      </a:r>
                      <a:endParaRPr lang="en-US" sz="1100" b="0" i="1" u="none" strike="noStrike" baseline="30000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664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Medicago</a:t>
                      </a:r>
                      <a:r>
                        <a:rPr lang="en-US" sz="110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truncatul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Citrullus</a:t>
                      </a:r>
                      <a:r>
                        <a:rPr lang="en-US" sz="110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lanatus</a:t>
                      </a:r>
                      <a:r>
                        <a:rPr lang="en-US" sz="110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i="0" u="none" strike="noStrike" dirty="0">
                          <a:latin typeface="Calibri" pitchFamily="34" charset="0"/>
                          <a:cs typeface="Arial" pitchFamily="34" charset="0"/>
                        </a:rPr>
                        <a:t>var. </a:t>
                      </a:r>
                      <a:r>
                        <a:rPr lang="en-US" sz="1100" i="1" u="none" strike="noStrike" dirty="0" err="1" smtClean="0">
                          <a:latin typeface="Calibri" pitchFamily="34" charset="0"/>
                          <a:cs typeface="Arial" pitchFamily="34" charset="0"/>
                        </a:rPr>
                        <a:t>lanatus</a:t>
                      </a:r>
                      <a:r>
                        <a:rPr lang="en-US" sz="1100" i="1" u="none" strike="noStrike" baseline="0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i="0" u="none" strike="noStrike" baseline="30000" dirty="0" smtClean="0">
                          <a:latin typeface="Calibri" pitchFamily="34" charset="0"/>
                          <a:cs typeface="Arial" pitchFamily="34" charset="0"/>
                        </a:rPr>
                        <a:t>R</a:t>
                      </a:r>
                      <a:endParaRPr lang="en-US" sz="1100" b="0" i="0" u="none" strike="noStrike" baseline="30000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Cucumis</a:t>
                      </a:r>
                      <a:r>
                        <a:rPr lang="en-US" sz="110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sativus</a:t>
                      </a:r>
                      <a:r>
                        <a:rPr lang="en-US" sz="110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Theobroma</a:t>
                      </a:r>
                      <a:r>
                        <a:rPr lang="en-US" sz="1100" i="1" u="none" strike="noStrike" dirty="0">
                          <a:latin typeface="Calibri" pitchFamily="34" charset="0"/>
                          <a:cs typeface="Arial" pitchFamily="34" charset="0"/>
                        </a:rPr>
                        <a:t> cacao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664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TW" sz="1100" i="1" u="none" strike="noStrike" dirty="0" smtClean="0">
                          <a:latin typeface="Calibri" pitchFamily="34" charset="0"/>
                          <a:cs typeface="Arial" pitchFamily="34" charset="0"/>
                        </a:rPr>
                        <a:t>Arabidopsis</a:t>
                      </a:r>
                      <a:r>
                        <a:rPr lang="en-US" altLang="zh-TW" sz="1100" i="1" u="none" strike="noStrike" baseline="0" dirty="0" smtClean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i="1" u="none" strike="noStrike" dirty="0" smtClean="0">
                          <a:latin typeface="Calibri" pitchFamily="34" charset="0"/>
                          <a:cs typeface="Arial" pitchFamily="34" charset="0"/>
                        </a:rPr>
                        <a:t>DEG9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latin typeface="Courier New"/>
                          <a:cs typeface="Courier New"/>
                        </a:rPr>
                        <a:t>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Courier New"/>
                        <a:cs typeface="Courier New"/>
                      </a:endParaRPr>
                    </a:p>
                  </a:txBody>
                  <a:tcPr marL="0" marR="0" marT="0" marB="0" anchor="ctr"/>
                </a:tc>
              </a:tr>
              <a:tr h="266400">
                <a:tc>
                  <a:txBody>
                    <a:bodyPr/>
                    <a:lstStyle/>
                    <a:p>
                      <a:pPr algn="l" fontAlgn="ctr"/>
                      <a:endParaRPr lang="zh-TW" altLang="en-US" sz="11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u="none" strike="noStrike" dirty="0" smtClean="0">
                          <a:latin typeface="Calibri" pitchFamily="34" charset="0"/>
                          <a:cs typeface="Arial" pitchFamily="34" charset="0"/>
                        </a:rPr>
                        <a:t>0.969*</a:t>
                      </a:r>
                      <a:endParaRPr lang="en-US" altLang="zh-TW" sz="1100" b="0" i="0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u="none" strike="noStrike" dirty="0">
                          <a:latin typeface="Calibri" pitchFamily="34" charset="0"/>
                          <a:cs typeface="Arial" pitchFamily="34" charset="0"/>
                        </a:rPr>
                        <a:t>0.973*</a:t>
                      </a:r>
                      <a:endParaRPr lang="en-US" altLang="zh-TW" sz="1100" b="0" i="0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pic>
        <p:nvPicPr>
          <p:cNvPr id="2049" name="Picture 1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22286" y="3970196"/>
            <a:ext cx="1798712" cy="24612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1538482"/>
              </p:ext>
            </p:extLst>
          </p:nvPr>
        </p:nvGraphicFramePr>
        <p:xfrm>
          <a:off x="412751" y="1037509"/>
          <a:ext cx="6032500" cy="2476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3" name="Document" r:id="rId5" imgW="6032500" imgH="2476500" progId="Word.Document.12">
                  <p:embed/>
                </p:oleObj>
              </mc:Choice>
              <mc:Fallback>
                <p:oleObj name="Document" r:id="rId5" imgW="6032500" imgH="24765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2751" y="1037509"/>
                        <a:ext cx="6032500" cy="2476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93623" y="595870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93623" y="3410136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669548" y="3413890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0607594"/>
              </p:ext>
            </p:extLst>
          </p:nvPr>
        </p:nvGraphicFramePr>
        <p:xfrm>
          <a:off x="391479" y="7143967"/>
          <a:ext cx="6212520" cy="1026160"/>
        </p:xfrm>
        <a:graphic>
          <a:graphicData uri="http://schemas.openxmlformats.org/drawingml/2006/table">
            <a:tbl>
              <a:tblPr/>
              <a:tblGrid>
                <a:gridCol w="946254"/>
                <a:gridCol w="1124586"/>
                <a:gridCol w="1035420"/>
                <a:gridCol w="1035420"/>
                <a:gridCol w="1035420"/>
                <a:gridCol w="1035420"/>
              </a:tblGrid>
              <a:tr h="2565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triculari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ibb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cf00003.g611.t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iti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inifer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VIVT0100780300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heobrom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cacao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c03_g000680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5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mul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uttat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u-H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gf024070m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dicago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runcatul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dtr4g106730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rabidopsis thalian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5G40200.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5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ffea canephora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COCT0001135700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itrull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nat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ar.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nat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a008304;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itrus sinensis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range1.1g036586m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5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anum lycopersicum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yc12g026400.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ucumis sativus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u-H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sa1M045910.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hu-HU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33554" y="270933"/>
            <a:ext cx="1839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. Fig. 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07252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表格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3477981"/>
              </p:ext>
            </p:extLst>
          </p:nvPr>
        </p:nvGraphicFramePr>
        <p:xfrm>
          <a:off x="1270001" y="3486975"/>
          <a:ext cx="5354318" cy="23955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35761"/>
                <a:gridCol w="413173"/>
                <a:gridCol w="413173"/>
                <a:gridCol w="413173"/>
                <a:gridCol w="413173"/>
                <a:gridCol w="413173"/>
                <a:gridCol w="413173"/>
                <a:gridCol w="413173"/>
                <a:gridCol w="413173"/>
                <a:gridCol w="413173"/>
              </a:tblGrid>
              <a:tr h="184275">
                <a:tc>
                  <a:txBody>
                    <a:bodyPr/>
                    <a:lstStyle/>
                    <a:p>
                      <a:pPr algn="l" fontAlgn="ctr"/>
                      <a:endParaRPr lang="zh-TW" altLang="en-US" sz="800" b="1" i="0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0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223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2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73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79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38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1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48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1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527</a:t>
                      </a:r>
                    </a:p>
                  </a:txBody>
                  <a:tcPr marL="0" marR="0" marT="0" marB="0" anchor="ctr"/>
                </a:tc>
              </a:tr>
              <a:tr h="184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Utricularia</a:t>
                      </a:r>
                      <a:r>
                        <a:rPr lang="en-US" sz="1100" b="1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b="1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gibba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M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Y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C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T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4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Mimulus</a:t>
                      </a:r>
                      <a:r>
                        <a:rPr lang="en-US" sz="1100" b="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guttatus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/>
                </a:tc>
              </a:tr>
              <a:tr h="184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Solanum</a:t>
                      </a:r>
                      <a:r>
                        <a:rPr lang="en-US" sz="1100" b="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lycopersicum</a:t>
                      </a:r>
                      <a:r>
                        <a:rPr lang="en-US" sz="1100" b="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F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42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 dirty="0">
                          <a:latin typeface="Calibri" pitchFamily="34" charset="0"/>
                          <a:cs typeface="Arial" pitchFamily="34" charset="0"/>
                        </a:rPr>
                        <a:t>Citrus </a:t>
                      </a:r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clementin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/>
                </a:tc>
              </a:tr>
              <a:tr h="184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Theobroma</a:t>
                      </a:r>
                      <a:r>
                        <a:rPr lang="en-US" sz="1100" b="0" i="1" u="none" strike="noStrike" dirty="0">
                          <a:latin typeface="Calibri" pitchFamily="34" charset="0"/>
                          <a:cs typeface="Arial" pitchFamily="34" charset="0"/>
                        </a:rPr>
                        <a:t> cacao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427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TW" sz="1100" i="1" u="none" strike="noStrike" dirty="0" smtClean="0">
                          <a:latin typeface="Calibri" pitchFamily="34" charset="0"/>
                          <a:cs typeface="Arial" pitchFamily="34" charset="0"/>
                        </a:rPr>
                        <a:t>Arabidopsis </a:t>
                      </a:r>
                      <a:r>
                        <a:rPr lang="en-US" sz="1100" b="0" i="1" u="none" strike="noStrike" dirty="0" smtClean="0">
                          <a:latin typeface="Calibri" pitchFamily="34" charset="0"/>
                          <a:cs typeface="Arial" pitchFamily="34" charset="0"/>
                        </a:rPr>
                        <a:t>DEG10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R</a:t>
                      </a:r>
                    </a:p>
                  </a:txBody>
                  <a:tcPr marL="0" marR="0" marT="0" marB="0" anchor="ctr"/>
                </a:tc>
              </a:tr>
              <a:tr h="184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Carica</a:t>
                      </a:r>
                      <a:r>
                        <a:rPr lang="en-US" sz="1100" b="0" i="1" u="none" strike="noStrike" dirty="0">
                          <a:latin typeface="Calibri" pitchFamily="34" charset="0"/>
                          <a:cs typeface="Arial" pitchFamily="34" charset="0"/>
                        </a:rPr>
                        <a:t> papay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4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Glycine</a:t>
                      </a:r>
                      <a:r>
                        <a:rPr lang="en-US" sz="1100" b="0" i="1" u="none" strike="noStrike" dirty="0">
                          <a:latin typeface="Calibri" pitchFamily="34" charset="0"/>
                          <a:cs typeface="Arial" pitchFamily="34" charset="0"/>
                        </a:rPr>
                        <a:t> max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/>
                </a:tc>
              </a:tr>
              <a:tr h="184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Cucumis</a:t>
                      </a:r>
                      <a:r>
                        <a:rPr lang="en-US" sz="1100" b="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sativus</a:t>
                      </a:r>
                      <a:r>
                        <a:rPr lang="en-US" sz="1100" b="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4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Citrullus</a:t>
                      </a:r>
                      <a:r>
                        <a:rPr lang="en-US" sz="1100" b="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lanatus</a:t>
                      </a:r>
                      <a:r>
                        <a:rPr lang="en-US" sz="1100" b="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b="0" i="0" u="none" strike="noStrike" dirty="0">
                          <a:latin typeface="Calibri" pitchFamily="34" charset="0"/>
                          <a:cs typeface="Arial" pitchFamily="34" charset="0"/>
                        </a:rPr>
                        <a:t>var. </a:t>
                      </a:r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lanatus</a:t>
                      </a:r>
                      <a:r>
                        <a:rPr lang="en-US" sz="1100" b="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E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S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F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/>
                </a:tc>
              </a:tr>
              <a:tr h="184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Vitis</a:t>
                      </a:r>
                      <a:r>
                        <a:rPr lang="en-US" sz="1100" b="0" i="1" u="none" strike="noStrike" dirty="0">
                          <a:latin typeface="Calibri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b="0" i="1" u="none" strike="noStrike" dirty="0" err="1">
                          <a:latin typeface="Calibri" pitchFamily="34" charset="0"/>
                          <a:cs typeface="Arial" pitchFamily="34" charset="0"/>
                        </a:rPr>
                        <a:t>vinifera</a:t>
                      </a:r>
                      <a:endParaRPr lang="en-US" sz="1100" b="0" i="1" u="none" strike="noStrike" dirty="0">
                        <a:solidFill>
                          <a:srgbClr val="000000"/>
                        </a:solidFill>
                        <a:latin typeface="Calibri" pitchFamily="34" charset="0"/>
                        <a:cs typeface="Arial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I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V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P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A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L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ourier New"/>
                          <a:cs typeface="Courier New"/>
                        </a:rPr>
                        <a:t>K</a:t>
                      </a:r>
                    </a:p>
                  </a:txBody>
                  <a:tcPr marL="0" marR="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184275">
                <a:tc>
                  <a:txBody>
                    <a:bodyPr/>
                    <a:lstStyle/>
                    <a:p>
                      <a:pPr algn="l" fontAlgn="ctr"/>
                      <a:endParaRPr lang="zh-TW" altLang="en-US" sz="800" b="1" i="0" u="none" strike="noStrike" dirty="0">
                        <a:solidFill>
                          <a:srgbClr val="000000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80*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665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64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65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69*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 smtClean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96 *</a:t>
                      </a:r>
                      <a:r>
                        <a:rPr lang="en-US" altLang="zh-TW" sz="9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*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80*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25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900" b="0" i="0" u="none" strike="noStrike" dirty="0">
                          <a:solidFill>
                            <a:srgbClr val="000000"/>
                          </a:solidFill>
                          <a:latin typeface="Calibri" pitchFamily="34" charset="0"/>
                        </a:rPr>
                        <a:t>0.982*</a:t>
                      </a:r>
                    </a:p>
                  </a:txBody>
                  <a:tcPr marL="0" marR="0" marT="0" marB="0" anchor="ctr"/>
                </a:tc>
              </a:tr>
            </a:tbl>
          </a:graphicData>
        </a:graphic>
      </p:graphicFrame>
      <p:pic>
        <p:nvPicPr>
          <p:cNvPr id="14" name="圖片 13" descr="DEG10-tree-label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6264" y="3724333"/>
            <a:ext cx="990000" cy="1980000"/>
          </a:xfrm>
          <a:prstGeom prst="rect">
            <a:avLst/>
          </a:prstGeom>
        </p:spPr>
      </p:pic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2358829"/>
              </p:ext>
            </p:extLst>
          </p:nvPr>
        </p:nvGraphicFramePr>
        <p:xfrm>
          <a:off x="451728" y="825919"/>
          <a:ext cx="6032500" cy="2336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17" name="Document" r:id="rId5" imgW="6032500" imgH="2336800" progId="Word.Document.12">
                  <p:embed/>
                </p:oleObj>
              </mc:Choice>
              <mc:Fallback>
                <p:oleObj name="Document" r:id="rId5" imgW="6032500" imgH="23368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51728" y="825919"/>
                        <a:ext cx="6032500" cy="2336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93623" y="392674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93623" y="3308538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518082" y="3312292"/>
            <a:ext cx="273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2777909"/>
              </p:ext>
            </p:extLst>
          </p:nvPr>
        </p:nvGraphicFramePr>
        <p:xfrm>
          <a:off x="316264" y="6364763"/>
          <a:ext cx="6270803" cy="1026160"/>
        </p:xfrm>
        <a:graphic>
          <a:graphicData uri="http://schemas.openxmlformats.org/drawingml/2006/table">
            <a:tbl>
              <a:tblPr/>
              <a:tblGrid>
                <a:gridCol w="1072269"/>
                <a:gridCol w="1168400"/>
                <a:gridCol w="948267"/>
                <a:gridCol w="914400"/>
                <a:gridCol w="1117600"/>
                <a:gridCol w="1049867"/>
              </a:tblGrid>
              <a:tr h="2565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triculari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ibba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cf00324.g15492.t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heobroma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cacao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c05_g015840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ucumi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tiv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u-HU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sa2M072480.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5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mul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uttat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u-H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gf007115m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rabidopsis thalian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5G36950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itrull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natu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var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natus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a005757;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5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anum lycopersicum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v-S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yc11g008850.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rica papay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VM prediction supercontig_108.24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itis vinifer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VIVG01003912001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65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itrus clementin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ementine0.9_005703m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ycine max 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C:26340109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33554" y="86267"/>
            <a:ext cx="1839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. Fig. 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1648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1260</Words>
  <Application>Microsoft Macintosh PowerPoint</Application>
  <PresentationFormat>On-screen Show (4:3)</PresentationFormat>
  <Paragraphs>916</Paragraphs>
  <Slides>7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9" baseType="lpstr">
      <vt:lpstr>Office Theme</vt:lpstr>
      <vt:lpstr>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renzo</dc:creator>
  <cp:lastModifiedBy>Chang Tien-Hao</cp:lastModifiedBy>
  <cp:revision>20</cp:revision>
  <dcterms:created xsi:type="dcterms:W3CDTF">2014-06-03T20:01:42Z</dcterms:created>
  <dcterms:modified xsi:type="dcterms:W3CDTF">2014-10-07T19:20:17Z</dcterms:modified>
</cp:coreProperties>
</file>